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43"/>
    <p:restoredTop sz="96327"/>
  </p:normalViewPr>
  <p:slideViewPr>
    <p:cSldViewPr snapToGrid="0" snapToObjects="1">
      <p:cViewPr varScale="1">
        <p:scale>
          <a:sx n="114" d="100"/>
          <a:sy n="114" d="100"/>
        </p:scale>
        <p:origin x="132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1EB69-599B-C248-BADE-0C40877ABFD3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BF922-2DBB-7E46-BE83-735604EBBC64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598318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1EB69-599B-C248-BADE-0C40877ABFD3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BF922-2DBB-7E46-BE83-735604EBBC64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2872802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1EB69-599B-C248-BADE-0C40877ABFD3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BF922-2DBB-7E46-BE83-735604EBBC64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8076188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1EB69-599B-C248-BADE-0C40877ABFD3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BF922-2DBB-7E46-BE83-735604EBBC64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6974595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1EB69-599B-C248-BADE-0C40877ABFD3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BF922-2DBB-7E46-BE83-735604EBBC64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6928954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1EB69-599B-C248-BADE-0C40877ABFD3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BF922-2DBB-7E46-BE83-735604EBBC64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0833066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1EB69-599B-C248-BADE-0C40877ABFD3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BF922-2DBB-7E46-BE83-735604EBBC64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3046460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1EB69-599B-C248-BADE-0C40877ABFD3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BF922-2DBB-7E46-BE83-735604EBBC64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6709669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1EB69-599B-C248-BADE-0C40877ABFD3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BF922-2DBB-7E46-BE83-735604EBBC64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253702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1EB69-599B-C248-BADE-0C40877ABFD3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BF922-2DBB-7E46-BE83-735604EBBC64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567908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81EB69-599B-C248-BADE-0C40877ABFD3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EBF922-2DBB-7E46-BE83-735604EBBC64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920695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81EB69-599B-C248-BADE-0C40877ABFD3}" type="datetimeFigureOut">
              <a:rPr lang="en-JP" smtClean="0"/>
              <a:t>02/08/2022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EBF922-2DBB-7E46-BE83-735604EBBC64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524047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38E33C05-FAA9-41E8-88EE-12796CC24682}"/>
              </a:ext>
            </a:extLst>
          </p:cNvPr>
          <p:cNvGrpSpPr/>
          <p:nvPr/>
        </p:nvGrpSpPr>
        <p:grpSpPr>
          <a:xfrm>
            <a:off x="-58722" y="-67100"/>
            <a:ext cx="10076614" cy="6969910"/>
            <a:chOff x="-58722" y="-67100"/>
            <a:chExt cx="10076614" cy="6969910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78CD2B26-C9A0-114C-8659-902E2C16E27C}"/>
                </a:ext>
              </a:extLst>
            </p:cNvPr>
            <p:cNvSpPr txBox="1"/>
            <p:nvPr/>
          </p:nvSpPr>
          <p:spPr>
            <a:xfrm>
              <a:off x="2109399" y="4511177"/>
              <a:ext cx="451000" cy="2362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4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YNU</a:t>
              </a:r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21F24114-97D9-0746-B710-471D21C65603}"/>
                </a:ext>
              </a:extLst>
            </p:cNvPr>
            <p:cNvSpPr/>
            <p:nvPr/>
          </p:nvSpPr>
          <p:spPr>
            <a:xfrm>
              <a:off x="-58722" y="-36597"/>
              <a:ext cx="10006963" cy="6939407"/>
            </a:xfrm>
            <a:prstGeom prst="rect">
              <a:avLst/>
            </a:prstGeom>
            <a:ln>
              <a:noFill/>
              <a:prstDash val="lgDash"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pic>
          <p:nvPicPr>
            <p:cNvPr id="4" name="Picture 31">
              <a:extLst>
                <a:ext uri="{FF2B5EF4-FFF2-40B4-BE49-F238E27FC236}">
                  <a16:creationId xmlns:a16="http://schemas.microsoft.com/office/drawing/2014/main" id="{A4EED63D-6ABF-6D44-B8A5-3834AEE864B4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977"/>
            <a:stretch/>
          </p:blipFill>
          <p:spPr bwMode="auto">
            <a:xfrm>
              <a:off x="298606" y="4043208"/>
              <a:ext cx="4398899" cy="27634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562227B-A0DC-B741-99E7-3FFEAC7337D8}"/>
                </a:ext>
              </a:extLst>
            </p:cNvPr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498876" y="4048736"/>
              <a:ext cx="4398899" cy="2763452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A592381-20D1-764F-B694-C229BBAA93E0}"/>
                </a:ext>
              </a:extLst>
            </p:cNvPr>
            <p:cNvSpPr txBox="1"/>
            <p:nvPr/>
          </p:nvSpPr>
          <p:spPr>
            <a:xfrm>
              <a:off x="2287968" y="3453504"/>
              <a:ext cx="468138" cy="3543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9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d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38BFD210-FA3D-6B4B-9E49-32372FEC18D7}"/>
                </a:ext>
              </a:extLst>
            </p:cNvPr>
            <p:cNvSpPr/>
            <p:nvPr/>
          </p:nvSpPr>
          <p:spPr>
            <a:xfrm rot="5400000">
              <a:off x="-477006" y="5359449"/>
              <a:ext cx="1919021" cy="125865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C438816-1959-E14B-9681-BAE8E104B377}"/>
                </a:ext>
              </a:extLst>
            </p:cNvPr>
            <p:cNvSpPr txBox="1"/>
            <p:nvPr/>
          </p:nvSpPr>
          <p:spPr>
            <a:xfrm>
              <a:off x="46561" y="4281959"/>
              <a:ext cx="507831" cy="821700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</a:p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0mM NaCl)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AE7D9E8-4282-6B4A-8120-6E178AE716C0}"/>
                </a:ext>
              </a:extLst>
            </p:cNvPr>
            <p:cNvSpPr txBox="1"/>
            <p:nvPr/>
          </p:nvSpPr>
          <p:spPr>
            <a:xfrm>
              <a:off x="91994" y="5419137"/>
              <a:ext cx="669415" cy="1397177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alt stress-release</a:t>
              </a:r>
            </a:p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75mM → 0mM NaCl)</a:t>
              </a:r>
            </a:p>
            <a:p>
              <a:pPr algn="ctr"/>
              <a:endParaRPr lang="en-JP" sz="105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B56D5D70-AC2A-7B40-8884-F38067B66765}"/>
                </a:ext>
              </a:extLst>
            </p:cNvPr>
            <p:cNvGrpSpPr/>
            <p:nvPr/>
          </p:nvGrpSpPr>
          <p:grpSpPr>
            <a:xfrm>
              <a:off x="114008" y="-36532"/>
              <a:ext cx="4338191" cy="3313843"/>
              <a:chOff x="294105" y="288844"/>
              <a:chExt cx="2840254" cy="2158502"/>
            </a:xfrm>
          </p:grpSpPr>
          <p:pic>
            <p:nvPicPr>
              <p:cNvPr id="12" name="Picture 25">
                <a:extLst>
                  <a:ext uri="{FF2B5EF4-FFF2-40B4-BE49-F238E27FC236}">
                    <a16:creationId xmlns:a16="http://schemas.microsoft.com/office/drawing/2014/main" id="{B6DF46EF-0EEA-5648-B875-98FA88D622C3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6359" y="601154"/>
                <a:ext cx="2808000" cy="180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B824EB8C-4010-A94E-A03B-1F5C9115626C}"/>
                  </a:ext>
                </a:extLst>
              </p:cNvPr>
              <p:cNvSpPr txBox="1"/>
              <p:nvPr/>
            </p:nvSpPr>
            <p:spPr>
              <a:xfrm>
                <a:off x="1718628" y="288844"/>
                <a:ext cx="218507" cy="17040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1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d</a:t>
                </a:r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D337CAC0-A98D-1F4A-B7B1-94ACDF52B695}"/>
                  </a:ext>
                </a:extLst>
              </p:cNvPr>
              <p:cNvSpPr/>
              <p:nvPr/>
            </p:nvSpPr>
            <p:spPr>
              <a:xfrm>
                <a:off x="868929" y="639910"/>
                <a:ext cx="1973172" cy="123261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JP"/>
              </a:p>
            </p:txBody>
          </p: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D651AA05-7FB5-6745-A9B3-0AD493206362}"/>
                  </a:ext>
                </a:extLst>
              </p:cNvPr>
              <p:cNvSpPr/>
              <p:nvPr/>
            </p:nvSpPr>
            <p:spPr>
              <a:xfrm rot="5400000" flipV="1">
                <a:off x="-118447" y="1589771"/>
                <a:ext cx="1240040" cy="154358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JP"/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7792D4D5-3780-9347-9B8F-B49A65F72BCD}"/>
                  </a:ext>
                </a:extLst>
              </p:cNvPr>
              <p:cNvSpPr txBox="1"/>
              <p:nvPr/>
            </p:nvSpPr>
            <p:spPr>
              <a:xfrm>
                <a:off x="1013917" y="504288"/>
                <a:ext cx="475635" cy="2706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JP" sz="105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T </a:t>
                </a:r>
              </a:p>
              <a:p>
                <a:pPr algn="ctr"/>
                <a:r>
                  <a:rPr lang="en-JP" sz="105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26/23℃)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4B70100D-E03E-FC41-814E-6D0DA9176DD7}"/>
                  </a:ext>
                </a:extLst>
              </p:cNvPr>
              <p:cNvSpPr txBox="1"/>
              <p:nvPr/>
            </p:nvSpPr>
            <p:spPr>
              <a:xfrm>
                <a:off x="2197215" y="504329"/>
                <a:ext cx="475635" cy="2706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JP" sz="105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T </a:t>
                </a:r>
              </a:p>
              <a:p>
                <a:pPr algn="ctr"/>
                <a:r>
                  <a:rPr lang="en-JP" sz="105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30/26℃)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4B3CBB69-3718-5843-94E7-45C39E3D89D6}"/>
                  </a:ext>
                </a:extLst>
              </p:cNvPr>
              <p:cNvSpPr txBox="1"/>
              <p:nvPr/>
            </p:nvSpPr>
            <p:spPr>
              <a:xfrm>
                <a:off x="294105" y="951077"/>
                <a:ext cx="332482" cy="535222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ctr"/>
                <a:r>
                  <a:rPr lang="en-JP" sz="105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</a:p>
              <a:p>
                <a:pPr algn="ctr"/>
                <a:r>
                  <a:rPr lang="en-JP" sz="105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0mM NaCl)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F01FB2A0-A64B-8B46-9DA3-AC6B4FCF0EE3}"/>
                  </a:ext>
                </a:extLst>
              </p:cNvPr>
              <p:cNvSpPr txBox="1"/>
              <p:nvPr/>
            </p:nvSpPr>
            <p:spPr>
              <a:xfrm>
                <a:off x="310020" y="1694865"/>
                <a:ext cx="332482" cy="579075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ctr"/>
                <a:r>
                  <a:rPr lang="en-JP" sz="105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lt stress</a:t>
                </a:r>
              </a:p>
              <a:p>
                <a:pPr algn="ctr"/>
                <a:r>
                  <a:rPr lang="en-JP" sz="105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75mM NaCl)</a:t>
                </a:r>
              </a:p>
            </p:txBody>
          </p:sp>
          <p:sp>
            <p:nvSpPr>
              <p:cNvPr id="20" name="Rectangle 19">
                <a:extLst>
                  <a:ext uri="{FF2B5EF4-FFF2-40B4-BE49-F238E27FC236}">
                    <a16:creationId xmlns:a16="http://schemas.microsoft.com/office/drawing/2014/main" id="{857A9B94-8741-D04B-B5B9-785360452A4D}"/>
                  </a:ext>
                </a:extLst>
              </p:cNvPr>
              <p:cNvSpPr/>
              <p:nvPr/>
            </p:nvSpPr>
            <p:spPr>
              <a:xfrm>
                <a:off x="849476" y="1522800"/>
                <a:ext cx="1942445" cy="86941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JP"/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57DA1DFA-713C-194B-862E-670CFB41479B}"/>
                  </a:ext>
                </a:extLst>
              </p:cNvPr>
              <p:cNvSpPr txBox="1"/>
              <p:nvPr/>
            </p:nvSpPr>
            <p:spPr>
              <a:xfrm>
                <a:off x="906412" y="1481074"/>
                <a:ext cx="260487" cy="1603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8293A6F1-5B06-D344-9179-E0E14E3CFDC7}"/>
                  </a:ext>
                </a:extLst>
              </p:cNvPr>
              <p:cNvSpPr txBox="1"/>
              <p:nvPr/>
            </p:nvSpPr>
            <p:spPr>
              <a:xfrm>
                <a:off x="1191859" y="1485809"/>
                <a:ext cx="303515" cy="1603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NU</a:t>
                </a:r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DD5A6593-6DC2-594F-A73F-4745062FB436}"/>
                  </a:ext>
                </a:extLst>
              </p:cNvPr>
              <p:cNvSpPr/>
              <p:nvPr/>
            </p:nvSpPr>
            <p:spPr>
              <a:xfrm>
                <a:off x="816954" y="2325887"/>
                <a:ext cx="1973171" cy="86940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JP"/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7EA9DA2B-D185-1E41-98A4-349D505255D2}"/>
                  </a:ext>
                </a:extLst>
              </p:cNvPr>
              <p:cNvSpPr txBox="1"/>
              <p:nvPr/>
            </p:nvSpPr>
            <p:spPr>
              <a:xfrm>
                <a:off x="1192419" y="2273603"/>
                <a:ext cx="303515" cy="1603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NU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7B6ACD9F-883F-714B-97EB-006C84BC4141}"/>
                  </a:ext>
                </a:extLst>
              </p:cNvPr>
              <p:cNvSpPr txBox="1"/>
              <p:nvPr/>
            </p:nvSpPr>
            <p:spPr>
              <a:xfrm>
                <a:off x="905629" y="2268868"/>
                <a:ext cx="260487" cy="1603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0A393F97-6129-204E-9368-5F5A4B587082}"/>
                  </a:ext>
                </a:extLst>
              </p:cNvPr>
              <p:cNvSpPr txBox="1"/>
              <p:nvPr/>
            </p:nvSpPr>
            <p:spPr>
              <a:xfrm>
                <a:off x="2436580" y="2282047"/>
                <a:ext cx="303515" cy="1603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NU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503DE9C8-CCE8-F847-940A-D221685AF7D0}"/>
                  </a:ext>
                </a:extLst>
              </p:cNvPr>
              <p:cNvSpPr txBox="1"/>
              <p:nvPr/>
            </p:nvSpPr>
            <p:spPr>
              <a:xfrm>
                <a:off x="2160662" y="2286968"/>
                <a:ext cx="260487" cy="1603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13765270-39DA-CD4C-AF61-A9C8700211E0}"/>
                  </a:ext>
                </a:extLst>
              </p:cNvPr>
              <p:cNvSpPr txBox="1"/>
              <p:nvPr/>
            </p:nvSpPr>
            <p:spPr>
              <a:xfrm>
                <a:off x="2449718" y="1493295"/>
                <a:ext cx="303515" cy="1603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NU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910A1E71-02F2-DC48-B52B-E6C58A57E38A}"/>
                  </a:ext>
                </a:extLst>
              </p:cNvPr>
              <p:cNvSpPr txBox="1"/>
              <p:nvPr/>
            </p:nvSpPr>
            <p:spPr>
              <a:xfrm>
                <a:off x="2159283" y="1489325"/>
                <a:ext cx="260487" cy="1603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</a:p>
            </p:txBody>
          </p:sp>
        </p:grp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3556D6DD-0860-3B44-B517-525FB446FCE7}"/>
                </a:ext>
              </a:extLst>
            </p:cNvPr>
            <p:cNvSpPr/>
            <p:nvPr/>
          </p:nvSpPr>
          <p:spPr>
            <a:xfrm>
              <a:off x="5882105" y="6568395"/>
              <a:ext cx="3621315" cy="165720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F726F0FF-980E-004E-BBE0-80341FCDD6D8}"/>
                </a:ext>
              </a:extLst>
            </p:cNvPr>
            <p:cNvSpPr/>
            <p:nvPr/>
          </p:nvSpPr>
          <p:spPr>
            <a:xfrm>
              <a:off x="631001" y="5249317"/>
              <a:ext cx="3732478" cy="218477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3E0F08D-DE2F-D349-8D02-9CA06E72E593}"/>
                </a:ext>
              </a:extLst>
            </p:cNvPr>
            <p:cNvSpPr txBox="1"/>
            <p:nvPr/>
          </p:nvSpPr>
          <p:spPr>
            <a:xfrm>
              <a:off x="1069079" y="5207839"/>
              <a:ext cx="4635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YNU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C7D7BE5B-E012-E748-9F46-4A397B7F5493}"/>
                </a:ext>
              </a:extLst>
            </p:cNvPr>
            <p:cNvSpPr txBox="1"/>
            <p:nvPr/>
          </p:nvSpPr>
          <p:spPr>
            <a:xfrm>
              <a:off x="696239" y="5206990"/>
              <a:ext cx="3978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66E1D68F-9FCA-F94F-ADD3-4A66B1695FA2}"/>
                </a:ext>
              </a:extLst>
            </p:cNvPr>
            <p:cNvSpPr txBox="1"/>
            <p:nvPr/>
          </p:nvSpPr>
          <p:spPr>
            <a:xfrm>
              <a:off x="2063094" y="5225040"/>
              <a:ext cx="3978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67359C00-CFD1-EB41-9598-5EF12D602CB3}"/>
                </a:ext>
              </a:extLst>
            </p:cNvPr>
            <p:cNvSpPr/>
            <p:nvPr/>
          </p:nvSpPr>
          <p:spPr>
            <a:xfrm>
              <a:off x="564301" y="6490314"/>
              <a:ext cx="3781159" cy="206468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8A89928B-1799-3748-A6D2-CFB2803C5A8E}"/>
                </a:ext>
              </a:extLst>
            </p:cNvPr>
            <p:cNvSpPr txBox="1"/>
            <p:nvPr/>
          </p:nvSpPr>
          <p:spPr>
            <a:xfrm>
              <a:off x="3813155" y="5212612"/>
              <a:ext cx="4635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YNU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5B8B865-65CA-2144-BF9A-2E56729935B6}"/>
                </a:ext>
              </a:extLst>
            </p:cNvPr>
            <p:cNvSpPr txBox="1"/>
            <p:nvPr/>
          </p:nvSpPr>
          <p:spPr>
            <a:xfrm>
              <a:off x="3371116" y="5211863"/>
              <a:ext cx="3978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E2DF766C-E788-3246-9CA3-48287C6C529C}"/>
                </a:ext>
              </a:extLst>
            </p:cNvPr>
            <p:cNvSpPr txBox="1"/>
            <p:nvPr/>
          </p:nvSpPr>
          <p:spPr>
            <a:xfrm>
              <a:off x="2454881" y="6432968"/>
              <a:ext cx="4635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YNU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8047EE05-9780-234E-B11B-8BC461DD233D}"/>
                </a:ext>
              </a:extLst>
            </p:cNvPr>
            <p:cNvSpPr txBox="1"/>
            <p:nvPr/>
          </p:nvSpPr>
          <p:spPr>
            <a:xfrm>
              <a:off x="2025930" y="6441479"/>
              <a:ext cx="3978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281A3744-FBD7-F246-A8B9-1B5D81A643E5}"/>
                </a:ext>
              </a:extLst>
            </p:cNvPr>
            <p:cNvSpPr/>
            <p:nvPr/>
          </p:nvSpPr>
          <p:spPr>
            <a:xfrm>
              <a:off x="5667723" y="5369249"/>
              <a:ext cx="3976391" cy="145173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9D5A036A-4035-BB4D-B36B-BE2E3FB62A4C}"/>
                </a:ext>
              </a:extLst>
            </p:cNvPr>
            <p:cNvSpPr txBox="1"/>
            <p:nvPr/>
          </p:nvSpPr>
          <p:spPr>
            <a:xfrm>
              <a:off x="6352849" y="6531620"/>
              <a:ext cx="4635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YNU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493AA868-24B3-1447-B1BF-F375829267C2}"/>
                </a:ext>
              </a:extLst>
            </p:cNvPr>
            <p:cNvSpPr txBox="1"/>
            <p:nvPr/>
          </p:nvSpPr>
          <p:spPr>
            <a:xfrm>
              <a:off x="5918989" y="6527932"/>
              <a:ext cx="3850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1A1CE2F2-A94E-7A40-902D-622023F6F8AB}"/>
                </a:ext>
              </a:extLst>
            </p:cNvPr>
            <p:cNvSpPr txBox="1"/>
            <p:nvPr/>
          </p:nvSpPr>
          <p:spPr>
            <a:xfrm>
              <a:off x="7692764" y="6527932"/>
              <a:ext cx="4635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YNU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81D7B8F-7D59-354A-BF5C-BF6083DF8A5E}"/>
                </a:ext>
              </a:extLst>
            </p:cNvPr>
            <p:cNvSpPr txBox="1"/>
            <p:nvPr/>
          </p:nvSpPr>
          <p:spPr>
            <a:xfrm>
              <a:off x="7256619" y="6527932"/>
              <a:ext cx="3850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4E545A41-D267-744F-B1C5-7CB26826C5F3}"/>
                </a:ext>
              </a:extLst>
            </p:cNvPr>
            <p:cNvSpPr txBox="1"/>
            <p:nvPr/>
          </p:nvSpPr>
          <p:spPr>
            <a:xfrm>
              <a:off x="9031544" y="6539290"/>
              <a:ext cx="4635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YNU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45737C2E-38AE-D349-B25C-6BB7C7BDAB54}"/>
                </a:ext>
              </a:extLst>
            </p:cNvPr>
            <p:cNvSpPr txBox="1"/>
            <p:nvPr/>
          </p:nvSpPr>
          <p:spPr>
            <a:xfrm>
              <a:off x="8591888" y="6531100"/>
              <a:ext cx="3850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45987A3A-97DC-694C-BA09-C2DEACB51A6F}"/>
                </a:ext>
              </a:extLst>
            </p:cNvPr>
            <p:cNvSpPr txBox="1"/>
            <p:nvPr/>
          </p:nvSpPr>
          <p:spPr>
            <a:xfrm>
              <a:off x="3856764" y="6432968"/>
              <a:ext cx="4635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YNU</a:t>
              </a: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619F07CF-9AFA-1944-9377-0D9E40B182AE}"/>
                </a:ext>
              </a:extLst>
            </p:cNvPr>
            <p:cNvSpPr/>
            <p:nvPr/>
          </p:nvSpPr>
          <p:spPr>
            <a:xfrm>
              <a:off x="827131" y="3937675"/>
              <a:ext cx="3614569" cy="235488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 dirty="0"/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FCB59F90-398F-A646-B764-353D7B0CF903}"/>
                </a:ext>
              </a:extLst>
            </p:cNvPr>
            <p:cNvSpPr txBox="1"/>
            <p:nvPr/>
          </p:nvSpPr>
          <p:spPr>
            <a:xfrm>
              <a:off x="3417108" y="6439823"/>
              <a:ext cx="3978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A1787B21-5902-A841-8C14-C32056FD9ADA}"/>
                </a:ext>
              </a:extLst>
            </p:cNvPr>
            <p:cNvSpPr txBox="1"/>
            <p:nvPr/>
          </p:nvSpPr>
          <p:spPr>
            <a:xfrm>
              <a:off x="772028" y="3748381"/>
              <a:ext cx="726483" cy="4154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T</a:t>
              </a:r>
            </a:p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26/23℃)</a:t>
              </a:r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E0D29E99-CEFB-4244-BE5F-FEB0A02462AF}"/>
                </a:ext>
              </a:extLst>
            </p:cNvPr>
            <p:cNvSpPr/>
            <p:nvPr/>
          </p:nvSpPr>
          <p:spPr>
            <a:xfrm>
              <a:off x="6149042" y="3903976"/>
              <a:ext cx="3240886" cy="282500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3EC9D714-2D47-9C41-97A6-AFAA858FC4FB}"/>
                </a:ext>
              </a:extLst>
            </p:cNvPr>
            <p:cNvSpPr txBox="1"/>
            <p:nvPr/>
          </p:nvSpPr>
          <p:spPr>
            <a:xfrm>
              <a:off x="2129082" y="3784036"/>
              <a:ext cx="726483" cy="4154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T</a:t>
              </a:r>
            </a:p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30/26℃)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75F81147-1F13-064E-8869-E4DD7C5F4FBD}"/>
                </a:ext>
              </a:extLst>
            </p:cNvPr>
            <p:cNvSpPr txBox="1"/>
            <p:nvPr/>
          </p:nvSpPr>
          <p:spPr>
            <a:xfrm>
              <a:off x="3138214" y="3752017"/>
              <a:ext cx="1346844" cy="4154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eat stress-release</a:t>
              </a:r>
            </a:p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30/26℃ →26/23℃)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32AF5D42-CD58-CA47-BAB4-AF0CB4DC0752}"/>
                </a:ext>
              </a:extLst>
            </p:cNvPr>
            <p:cNvSpPr txBox="1"/>
            <p:nvPr/>
          </p:nvSpPr>
          <p:spPr>
            <a:xfrm>
              <a:off x="8367017" y="3748834"/>
              <a:ext cx="1346844" cy="4154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eat stress-release</a:t>
              </a:r>
            </a:p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30/26℃ →26/23℃)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4BB7ED09-7735-4E4A-AA66-FDE368B9A711}"/>
                </a:ext>
              </a:extLst>
            </p:cNvPr>
            <p:cNvSpPr txBox="1"/>
            <p:nvPr/>
          </p:nvSpPr>
          <p:spPr>
            <a:xfrm>
              <a:off x="7355897" y="3739016"/>
              <a:ext cx="726483" cy="4154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T</a:t>
              </a:r>
            </a:p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30/26℃)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50A71B42-9E57-5646-BFDC-95A89FEE6546}"/>
                </a:ext>
              </a:extLst>
            </p:cNvPr>
            <p:cNvSpPr txBox="1"/>
            <p:nvPr/>
          </p:nvSpPr>
          <p:spPr>
            <a:xfrm>
              <a:off x="6009831" y="3747826"/>
              <a:ext cx="726483" cy="4154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T</a:t>
              </a:r>
            </a:p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26/23℃)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A45EEB80-A464-284E-AFC1-592D438020EC}"/>
                </a:ext>
              </a:extLst>
            </p:cNvPr>
            <p:cNvSpPr txBox="1"/>
            <p:nvPr/>
          </p:nvSpPr>
          <p:spPr>
            <a:xfrm>
              <a:off x="4368757" y="3354256"/>
              <a:ext cx="1518941" cy="338554"/>
            </a:xfrm>
            <a:prstGeom prst="rect">
              <a:avLst/>
            </a:prstGeom>
            <a:noFill/>
          </p:spPr>
          <p:txBody>
            <a:bodyPr vert="horz" wrap="none" rtlCol="0">
              <a:spAutoFit/>
            </a:bodyPr>
            <a:lstStyle/>
            <a:p>
              <a:pPr algn="ctr"/>
              <a:r>
                <a:rPr lang="en-JP" sz="16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tress recovery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A1CC0748-BFF4-A745-9EE5-3DB0B35C298F}"/>
                </a:ext>
              </a:extLst>
            </p:cNvPr>
            <p:cNvSpPr txBox="1"/>
            <p:nvPr/>
          </p:nvSpPr>
          <p:spPr>
            <a:xfrm>
              <a:off x="2503012" y="5217904"/>
              <a:ext cx="4635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YNU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12F9C9B6-EA97-884E-8AB6-F87D971E17B0}"/>
                </a:ext>
              </a:extLst>
            </p:cNvPr>
            <p:cNvSpPr txBox="1"/>
            <p:nvPr/>
          </p:nvSpPr>
          <p:spPr>
            <a:xfrm>
              <a:off x="1130823" y="6468108"/>
              <a:ext cx="4635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YNU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CBB03F94-E10A-B24A-B105-FE68FB0460D7}"/>
                </a:ext>
              </a:extLst>
            </p:cNvPr>
            <p:cNvSpPr txBox="1"/>
            <p:nvPr/>
          </p:nvSpPr>
          <p:spPr>
            <a:xfrm>
              <a:off x="706928" y="6459810"/>
              <a:ext cx="3978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FCF348F1-72EE-6149-8812-3FDBA6F664D3}"/>
                </a:ext>
              </a:extLst>
            </p:cNvPr>
            <p:cNvSpPr txBox="1"/>
            <p:nvPr/>
          </p:nvSpPr>
          <p:spPr>
            <a:xfrm>
              <a:off x="6355810" y="5330422"/>
              <a:ext cx="4635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YNU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3566D7AD-4B46-0C4F-A13E-83A07DFB047C}"/>
                </a:ext>
              </a:extLst>
            </p:cNvPr>
            <p:cNvSpPr txBox="1"/>
            <p:nvPr/>
          </p:nvSpPr>
          <p:spPr>
            <a:xfrm>
              <a:off x="5918989" y="5309290"/>
              <a:ext cx="3850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0700C643-240B-0145-956B-B06392471231}"/>
                </a:ext>
              </a:extLst>
            </p:cNvPr>
            <p:cNvSpPr txBox="1"/>
            <p:nvPr/>
          </p:nvSpPr>
          <p:spPr>
            <a:xfrm>
              <a:off x="7694071" y="5347845"/>
              <a:ext cx="4635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YNU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521BEF58-5752-2E4C-BB14-E9F2AF26AC29}"/>
                </a:ext>
              </a:extLst>
            </p:cNvPr>
            <p:cNvSpPr txBox="1"/>
            <p:nvPr/>
          </p:nvSpPr>
          <p:spPr>
            <a:xfrm>
              <a:off x="7251525" y="5338077"/>
              <a:ext cx="3850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117F86CA-A883-8849-9334-2F7F6078C463}"/>
                </a:ext>
              </a:extLst>
            </p:cNvPr>
            <p:cNvSpPr txBox="1"/>
            <p:nvPr/>
          </p:nvSpPr>
          <p:spPr>
            <a:xfrm>
              <a:off x="9027157" y="5319068"/>
              <a:ext cx="4635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YNU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E31C3EDB-4510-EA4D-9CEE-65DC46C3A5B2}"/>
                </a:ext>
              </a:extLst>
            </p:cNvPr>
            <p:cNvSpPr txBox="1"/>
            <p:nvPr/>
          </p:nvSpPr>
          <p:spPr>
            <a:xfrm>
              <a:off x="8602940" y="5314295"/>
              <a:ext cx="3850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0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67" name="Rectangle 66">
              <a:extLst>
                <a:ext uri="{FF2B5EF4-FFF2-40B4-BE49-F238E27FC236}">
                  <a16:creationId xmlns:a16="http://schemas.microsoft.com/office/drawing/2014/main" id="{43EE3FD0-AB37-B84A-BBA8-D9CDA2D596A0}"/>
                </a:ext>
              </a:extLst>
            </p:cNvPr>
            <p:cNvSpPr/>
            <p:nvPr/>
          </p:nvSpPr>
          <p:spPr>
            <a:xfrm rot="5400000" flipV="1">
              <a:off x="4692515" y="5330004"/>
              <a:ext cx="1898131" cy="185828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B13806FD-4368-9A4E-BB3F-2FE5D4DF4E46}"/>
                </a:ext>
              </a:extLst>
            </p:cNvPr>
            <p:cNvSpPr txBox="1"/>
            <p:nvPr/>
          </p:nvSpPr>
          <p:spPr>
            <a:xfrm>
              <a:off x="5198599" y="4410641"/>
              <a:ext cx="669415" cy="821700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</a:p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0mM NaCl)</a:t>
              </a:r>
            </a:p>
            <a:p>
              <a:pPr algn="ctr"/>
              <a:endParaRPr lang="en-JP" sz="105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A1FF49D3-A8AC-DC4B-A222-AADED9AED7F2}"/>
                </a:ext>
              </a:extLst>
            </p:cNvPr>
            <p:cNvSpPr txBox="1"/>
            <p:nvPr/>
          </p:nvSpPr>
          <p:spPr>
            <a:xfrm>
              <a:off x="5245433" y="5404274"/>
              <a:ext cx="669415" cy="1397177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alt stress-release</a:t>
              </a:r>
            </a:p>
            <a:p>
              <a:pPr algn="ctr"/>
              <a:r>
                <a:rPr lang="en-JP" sz="105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75mM → 0mM NaCl)</a:t>
              </a:r>
            </a:p>
            <a:p>
              <a:pPr algn="ctr"/>
              <a:endParaRPr lang="en-JP" sz="105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70" name="Group 69">
              <a:extLst>
                <a:ext uri="{FF2B5EF4-FFF2-40B4-BE49-F238E27FC236}">
                  <a16:creationId xmlns:a16="http://schemas.microsoft.com/office/drawing/2014/main" id="{2E86E8F0-1B32-A040-80B0-B229A577A40E}"/>
                </a:ext>
              </a:extLst>
            </p:cNvPr>
            <p:cNvGrpSpPr/>
            <p:nvPr/>
          </p:nvGrpSpPr>
          <p:grpSpPr>
            <a:xfrm>
              <a:off x="5198599" y="22185"/>
              <a:ext cx="4707400" cy="3451227"/>
              <a:chOff x="3607770" y="227743"/>
              <a:chExt cx="3081979" cy="2247988"/>
            </a:xfrm>
          </p:grpSpPr>
          <p:pic>
            <p:nvPicPr>
              <p:cNvPr id="71" name="Picture 28">
                <a:extLst>
                  <a:ext uri="{FF2B5EF4-FFF2-40B4-BE49-F238E27FC236}">
                    <a16:creationId xmlns:a16="http://schemas.microsoft.com/office/drawing/2014/main" id="{41E697FB-BA72-D348-BCF5-190D84CEF596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115" b="6175"/>
              <a:stretch/>
            </p:blipFill>
            <p:spPr bwMode="auto">
              <a:xfrm>
                <a:off x="3809749" y="661554"/>
                <a:ext cx="2880000" cy="180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F0D488A3-2EC6-8B42-BBF6-941E91072635}"/>
                  </a:ext>
                </a:extLst>
              </p:cNvPr>
              <p:cNvSpPr txBox="1"/>
              <p:nvPr/>
            </p:nvSpPr>
            <p:spPr>
              <a:xfrm>
                <a:off x="5140657" y="227743"/>
                <a:ext cx="264685" cy="17040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1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d</a:t>
                </a:r>
              </a:p>
            </p:txBody>
          </p:sp>
          <p:sp>
            <p:nvSpPr>
              <p:cNvPr id="73" name="Rectangle 72">
                <a:extLst>
                  <a:ext uri="{FF2B5EF4-FFF2-40B4-BE49-F238E27FC236}">
                    <a16:creationId xmlns:a16="http://schemas.microsoft.com/office/drawing/2014/main" id="{56AD8180-1889-1A48-B383-68B8BFD91D49}"/>
                  </a:ext>
                </a:extLst>
              </p:cNvPr>
              <p:cNvSpPr/>
              <p:nvPr/>
            </p:nvSpPr>
            <p:spPr>
              <a:xfrm>
                <a:off x="4072413" y="1488721"/>
                <a:ext cx="2263327" cy="102545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JP"/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E4E2831B-4489-354F-8934-A30927EF7EEE}"/>
                  </a:ext>
                </a:extLst>
              </p:cNvPr>
              <p:cNvSpPr txBox="1"/>
              <p:nvPr/>
            </p:nvSpPr>
            <p:spPr>
              <a:xfrm>
                <a:off x="4487232" y="1472661"/>
                <a:ext cx="303515" cy="1603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NU</a:t>
                </a: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5BD69F5C-DC28-D947-A378-2E07A5DC619C}"/>
                  </a:ext>
                </a:extLst>
              </p:cNvPr>
              <p:cNvSpPr txBox="1"/>
              <p:nvPr/>
            </p:nvSpPr>
            <p:spPr>
              <a:xfrm>
                <a:off x="4203180" y="1472661"/>
                <a:ext cx="260487" cy="1603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F586913F-673C-C740-B859-4BE0053869C2}"/>
                  </a:ext>
                </a:extLst>
              </p:cNvPr>
              <p:cNvSpPr txBox="1"/>
              <p:nvPr/>
            </p:nvSpPr>
            <p:spPr>
              <a:xfrm>
                <a:off x="5941842" y="1468014"/>
                <a:ext cx="303515" cy="1603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NU</a:t>
                </a:r>
              </a:p>
            </p:txBody>
          </p:sp>
          <p:sp>
            <p:nvSpPr>
              <p:cNvPr id="77" name="Rectangle 76">
                <a:extLst>
                  <a:ext uri="{FF2B5EF4-FFF2-40B4-BE49-F238E27FC236}">
                    <a16:creationId xmlns:a16="http://schemas.microsoft.com/office/drawing/2014/main" id="{52A52423-8250-4C4A-A4BF-3DA6EEBA0C89}"/>
                  </a:ext>
                </a:extLst>
              </p:cNvPr>
              <p:cNvSpPr/>
              <p:nvPr/>
            </p:nvSpPr>
            <p:spPr>
              <a:xfrm>
                <a:off x="4094081" y="2327009"/>
                <a:ext cx="2231127" cy="148722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JP"/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41B0467E-2F4A-DD4F-9165-36E43149FDEA}"/>
                  </a:ext>
                </a:extLst>
              </p:cNvPr>
              <p:cNvSpPr txBox="1"/>
              <p:nvPr/>
            </p:nvSpPr>
            <p:spPr>
              <a:xfrm>
                <a:off x="5655505" y="1472660"/>
                <a:ext cx="260487" cy="1603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F76CEBA0-0254-2743-AF92-4A480DAD7DE1}"/>
                  </a:ext>
                </a:extLst>
              </p:cNvPr>
              <p:cNvSpPr txBox="1"/>
              <p:nvPr/>
            </p:nvSpPr>
            <p:spPr>
              <a:xfrm>
                <a:off x="4459877" y="2300756"/>
                <a:ext cx="303515" cy="1603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NU</a:t>
                </a: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3F6363DC-F413-AA44-B0B1-83B48B1E33FB}"/>
                  </a:ext>
                </a:extLst>
              </p:cNvPr>
              <p:cNvSpPr txBox="1"/>
              <p:nvPr/>
            </p:nvSpPr>
            <p:spPr>
              <a:xfrm>
                <a:off x="4169517" y="2299197"/>
                <a:ext cx="260487" cy="1603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37362FEB-84BF-5F41-AB0E-81A36E82769C}"/>
                  </a:ext>
                </a:extLst>
              </p:cNvPr>
              <p:cNvSpPr txBox="1"/>
              <p:nvPr/>
            </p:nvSpPr>
            <p:spPr>
              <a:xfrm>
                <a:off x="5938122" y="2306454"/>
                <a:ext cx="303515" cy="1603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NU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5A116706-0DBF-9448-80B6-0944BAF585B2}"/>
                  </a:ext>
                </a:extLst>
              </p:cNvPr>
              <p:cNvSpPr txBox="1"/>
              <p:nvPr/>
            </p:nvSpPr>
            <p:spPr>
              <a:xfrm>
                <a:off x="5654070" y="2299197"/>
                <a:ext cx="260487" cy="1603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JP" sz="100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</a:t>
                </a:r>
              </a:p>
            </p:txBody>
          </p:sp>
          <p:sp>
            <p:nvSpPr>
              <p:cNvPr id="83" name="Rectangle 82">
                <a:extLst>
                  <a:ext uri="{FF2B5EF4-FFF2-40B4-BE49-F238E27FC236}">
                    <a16:creationId xmlns:a16="http://schemas.microsoft.com/office/drawing/2014/main" id="{F3FC5C51-356F-E344-B5A3-873BB7169E3B}"/>
                  </a:ext>
                </a:extLst>
              </p:cNvPr>
              <p:cNvSpPr/>
              <p:nvPr/>
            </p:nvSpPr>
            <p:spPr>
              <a:xfrm rot="5400000" flipV="1">
                <a:off x="3243970" y="1559577"/>
                <a:ext cx="1326912" cy="121663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JP"/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A0D11875-E59D-6B44-9B2B-2D1354D0A25E}"/>
                  </a:ext>
                </a:extLst>
              </p:cNvPr>
              <p:cNvSpPr txBox="1"/>
              <p:nvPr/>
            </p:nvSpPr>
            <p:spPr>
              <a:xfrm>
                <a:off x="3607770" y="846798"/>
                <a:ext cx="332482" cy="535222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ctr"/>
                <a:r>
                  <a:rPr lang="en-JP" sz="105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trol</a:t>
                </a:r>
              </a:p>
              <a:p>
                <a:pPr algn="ctr"/>
                <a:r>
                  <a:rPr lang="en-JP" sz="105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0mM NaCl)</a:t>
                </a: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1D699858-5A83-1848-8D8C-8E81327B6AAE}"/>
                  </a:ext>
                </a:extLst>
              </p:cNvPr>
              <p:cNvSpPr txBox="1"/>
              <p:nvPr/>
            </p:nvSpPr>
            <p:spPr>
              <a:xfrm>
                <a:off x="3617089" y="1760687"/>
                <a:ext cx="332482" cy="579075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pPr algn="ctr"/>
                <a:r>
                  <a:rPr lang="en-JP" sz="105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lt stress</a:t>
                </a:r>
              </a:p>
              <a:p>
                <a:pPr algn="ctr"/>
                <a:r>
                  <a:rPr lang="en-JP" sz="105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75mM NaCl)</a:t>
                </a:r>
              </a:p>
            </p:txBody>
          </p:sp>
          <p:sp>
            <p:nvSpPr>
              <p:cNvPr id="86" name="Rectangle 85">
                <a:extLst>
                  <a:ext uri="{FF2B5EF4-FFF2-40B4-BE49-F238E27FC236}">
                    <a16:creationId xmlns:a16="http://schemas.microsoft.com/office/drawing/2014/main" id="{AA51AFC0-9EE1-9B43-86BF-9517DF0979E4}"/>
                  </a:ext>
                </a:extLst>
              </p:cNvPr>
              <p:cNvSpPr/>
              <p:nvPr/>
            </p:nvSpPr>
            <p:spPr>
              <a:xfrm>
                <a:off x="4189184" y="628921"/>
                <a:ext cx="1973172" cy="123261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JP"/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2737E816-1DE4-904D-9C9B-585BB7E2A361}"/>
                  </a:ext>
                </a:extLst>
              </p:cNvPr>
              <p:cNvSpPr txBox="1"/>
              <p:nvPr/>
            </p:nvSpPr>
            <p:spPr>
              <a:xfrm>
                <a:off x="4253056" y="404719"/>
                <a:ext cx="475635" cy="2706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JP" sz="105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T </a:t>
                </a:r>
              </a:p>
              <a:p>
                <a:pPr algn="ctr"/>
                <a:r>
                  <a:rPr lang="en-JP" sz="105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26/23℃)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FA7FD95F-A580-3E40-AD58-43363744736E}"/>
                  </a:ext>
                </a:extLst>
              </p:cNvPr>
              <p:cNvSpPr txBox="1"/>
              <p:nvPr/>
            </p:nvSpPr>
            <p:spPr>
              <a:xfrm>
                <a:off x="5699407" y="404719"/>
                <a:ext cx="475635" cy="2706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JP" sz="105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T </a:t>
                </a:r>
              </a:p>
              <a:p>
                <a:pPr algn="ctr"/>
                <a:r>
                  <a:rPr lang="en-JP" sz="1050" b="1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30/26℃)</a:t>
                </a:r>
              </a:p>
            </p:txBody>
          </p:sp>
        </p:grp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C8A1C48D-AF7C-0648-A0D7-A7D1C5456734}"/>
                </a:ext>
              </a:extLst>
            </p:cNvPr>
            <p:cNvCxnSpPr>
              <a:cxnSpLocks/>
              <a:stCxn id="16" idx="0"/>
              <a:endCxn id="17" idx="0"/>
            </p:cNvCxnSpPr>
            <p:nvPr/>
          </p:nvCxnSpPr>
          <p:spPr>
            <a:xfrm>
              <a:off x="1576688" y="294229"/>
              <a:ext cx="1807364" cy="63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id="{EC60AE36-2DCD-A74D-99B2-A9D8F5511C33}"/>
                </a:ext>
              </a:extLst>
            </p:cNvPr>
            <p:cNvCxnSpPr>
              <a:cxnSpLocks/>
              <a:stCxn id="87" idx="0"/>
              <a:endCxn id="88" idx="0"/>
            </p:cNvCxnSpPr>
            <p:nvPr/>
          </p:nvCxnSpPr>
          <p:spPr>
            <a:xfrm>
              <a:off x="6547448" y="293888"/>
              <a:ext cx="220914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ADD9E68D-72F5-0240-96C2-9ECF1110A222}"/>
                </a:ext>
              </a:extLst>
            </p:cNvPr>
            <p:cNvCxnSpPr>
              <a:cxnSpLocks/>
              <a:stCxn id="50" idx="0"/>
              <a:endCxn id="53" idx="0"/>
            </p:cNvCxnSpPr>
            <p:nvPr/>
          </p:nvCxnSpPr>
          <p:spPr>
            <a:xfrm>
              <a:off x="1135270" y="3748381"/>
              <a:ext cx="2676366" cy="3635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57133CBC-059D-434F-B7A2-1CA67BB96B16}"/>
                </a:ext>
              </a:extLst>
            </p:cNvPr>
            <p:cNvCxnSpPr>
              <a:cxnSpLocks/>
              <a:stCxn id="56" idx="0"/>
              <a:endCxn id="54" idx="0"/>
            </p:cNvCxnSpPr>
            <p:nvPr/>
          </p:nvCxnSpPr>
          <p:spPr>
            <a:xfrm>
              <a:off x="6373073" y="3747826"/>
              <a:ext cx="2667365" cy="1009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70A423CE-F82B-0947-BB31-080EF2FF243B}"/>
                </a:ext>
              </a:extLst>
            </p:cNvPr>
            <p:cNvSpPr txBox="1"/>
            <p:nvPr/>
          </p:nvSpPr>
          <p:spPr>
            <a:xfrm>
              <a:off x="7389794" y="3411074"/>
              <a:ext cx="40427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JP" sz="11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d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5B291A01-A752-4A45-B075-32DFCA1493FB}"/>
                </a:ext>
              </a:extLst>
            </p:cNvPr>
            <p:cNvSpPr txBox="1"/>
            <p:nvPr/>
          </p:nvSpPr>
          <p:spPr>
            <a:xfrm rot="5400000">
              <a:off x="4943119" y="-675824"/>
              <a:ext cx="430887" cy="1648336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pPr algn="ctr"/>
              <a:r>
                <a:rPr lang="en-JP" sz="16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tress application</a:t>
              </a:r>
            </a:p>
          </p:txBody>
        </p:sp>
        <p:sp>
          <p:nvSpPr>
            <p:cNvPr id="96" name="Rectangle 95">
              <a:extLst>
                <a:ext uri="{FF2B5EF4-FFF2-40B4-BE49-F238E27FC236}">
                  <a16:creationId xmlns:a16="http://schemas.microsoft.com/office/drawing/2014/main" id="{898AF7C0-E55B-254F-A482-6B4F49389069}"/>
                </a:ext>
              </a:extLst>
            </p:cNvPr>
            <p:cNvSpPr/>
            <p:nvPr/>
          </p:nvSpPr>
          <p:spPr>
            <a:xfrm>
              <a:off x="4308227" y="3076601"/>
              <a:ext cx="87676" cy="287591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5A7AF866-0097-F141-862B-A8193A17B97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91705" y="777925"/>
              <a:ext cx="0" cy="1050112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C4D641B5-6F90-EF4C-BBD1-58FF283A8D1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392313" y="794539"/>
              <a:ext cx="0" cy="1050112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1CFC3252-EB59-794A-8FFD-45227BAE7C3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539180" y="900079"/>
              <a:ext cx="0" cy="1050112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id="{E2361FC4-3620-A14A-A843-C46840E5F14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766249" y="891771"/>
              <a:ext cx="0" cy="1050112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1E55FF55-F839-224A-B6D9-DAFB7ED7295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26850" y="4284238"/>
              <a:ext cx="0" cy="939574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83DFA150-A42B-8C41-99A0-DB579CE2433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25779" y="5561773"/>
              <a:ext cx="0" cy="884305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id="{02F76E19-CC57-1D4C-BCA0-C05C1A24976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502083" y="4288486"/>
              <a:ext cx="0" cy="939574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Straight Connector 103">
              <a:extLst>
                <a:ext uri="{FF2B5EF4-FFF2-40B4-BE49-F238E27FC236}">
                  <a16:creationId xmlns:a16="http://schemas.microsoft.com/office/drawing/2014/main" id="{ABEA7D35-CD10-DC47-BBE4-9B4CD4A8DBD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454881" y="5531135"/>
              <a:ext cx="0" cy="884305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Straight Connector 104">
              <a:extLst>
                <a:ext uri="{FF2B5EF4-FFF2-40B4-BE49-F238E27FC236}">
                  <a16:creationId xmlns:a16="http://schemas.microsoft.com/office/drawing/2014/main" id="{61520ACC-AC99-B14C-AA13-D38333FD9A0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57312" y="5533478"/>
              <a:ext cx="0" cy="884305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838A9747-D730-9D49-A73D-0ABFAA9BD302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13155" y="4263348"/>
              <a:ext cx="0" cy="939574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136C6877-4E50-0D4D-B290-DDEA78562C3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93092" y="2071769"/>
              <a:ext cx="0" cy="939574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7F022550-943C-5943-B446-9A5B7D4A522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494327" y="2310727"/>
              <a:ext cx="0" cy="884305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Straight Connector 108">
              <a:extLst>
                <a:ext uri="{FF2B5EF4-FFF2-40B4-BE49-F238E27FC236}">
                  <a16:creationId xmlns:a16="http://schemas.microsoft.com/office/drawing/2014/main" id="{C41043D6-402E-3E41-BAE8-3240F6C0934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392313" y="2096687"/>
              <a:ext cx="0" cy="939574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id="{156656D1-745B-FF40-B316-0DF66A132DE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751647" y="2310727"/>
              <a:ext cx="0" cy="884305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DB2F86F8-11A8-B347-A46C-02A8C7536D7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352849" y="4378071"/>
              <a:ext cx="0" cy="939574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id="{CB436561-1977-9B4B-A861-6C4D0F6EBFC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692764" y="4408271"/>
              <a:ext cx="0" cy="939574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id="{1889943D-3979-BD4C-AC68-A05ED6A9F6D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041668" y="4341369"/>
              <a:ext cx="0" cy="939574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id="{57FE457B-98E5-044C-AD94-4B4B453E012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352800" y="5620625"/>
              <a:ext cx="0" cy="884305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Straight Connector 114">
              <a:extLst>
                <a:ext uri="{FF2B5EF4-FFF2-40B4-BE49-F238E27FC236}">
                  <a16:creationId xmlns:a16="http://schemas.microsoft.com/office/drawing/2014/main" id="{5C0847F0-39D0-E14C-9B0A-F8DF15D070E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673680" y="5591561"/>
              <a:ext cx="0" cy="884305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id="{A1FB630A-4110-2848-99D2-F29885557AB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033403" y="5601471"/>
              <a:ext cx="0" cy="884305"/>
            </a:xfrm>
            <a:prstGeom prst="line">
              <a:avLst/>
            </a:prstGeom>
            <a:ln w="12700">
              <a:solidFill>
                <a:schemeClr val="bg1"/>
              </a:solidFill>
              <a:prstDash val="lg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Rectangle 116">
              <a:extLst>
                <a:ext uri="{FF2B5EF4-FFF2-40B4-BE49-F238E27FC236}">
                  <a16:creationId xmlns:a16="http://schemas.microsoft.com/office/drawing/2014/main" id="{20F2533A-4C13-4B46-A193-2313D7A3C039}"/>
                </a:ext>
              </a:extLst>
            </p:cNvPr>
            <p:cNvSpPr/>
            <p:nvPr/>
          </p:nvSpPr>
          <p:spPr>
            <a:xfrm>
              <a:off x="4286017" y="2769737"/>
              <a:ext cx="150525" cy="371204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JP"/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FFD82ECD-BB24-44F2-B254-8BC1B3EE2AF7}"/>
                </a:ext>
              </a:extLst>
            </p:cNvPr>
            <p:cNvSpPr txBox="1"/>
            <p:nvPr/>
          </p:nvSpPr>
          <p:spPr>
            <a:xfrm rot="5400000">
              <a:off x="9549655" y="6330267"/>
              <a:ext cx="6286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 cm</a:t>
              </a:r>
              <a:endParaRPr lang="en-JP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20" name="TextBox 119">
            <a:extLst>
              <a:ext uri="{FF2B5EF4-FFF2-40B4-BE49-F238E27FC236}">
                <a16:creationId xmlns:a16="http://schemas.microsoft.com/office/drawing/2014/main" id="{1AF74143-0022-48B2-ADE9-A2900C949692}"/>
              </a:ext>
            </a:extLst>
          </p:cNvPr>
          <p:cNvSpPr txBox="1"/>
          <p:nvPr/>
        </p:nvSpPr>
        <p:spPr>
          <a:xfrm>
            <a:off x="46561" y="14988"/>
            <a:ext cx="9235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</a:t>
            </a:r>
            <a:r>
              <a:rPr lang="en-US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en-JP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01362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160</Words>
  <Application>Microsoft Office PowerPoint</Application>
  <PresentationFormat>A4 Paper (210x297 mm)</PresentationFormat>
  <Paragraphs>8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CAN Murat</dc:creator>
  <cp:lastModifiedBy>Marouane</cp:lastModifiedBy>
  <cp:revision>4</cp:revision>
  <dcterms:created xsi:type="dcterms:W3CDTF">2022-02-06T03:31:52Z</dcterms:created>
  <dcterms:modified xsi:type="dcterms:W3CDTF">2022-02-08T04:04:34Z</dcterms:modified>
</cp:coreProperties>
</file>